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2" d="100"/>
          <a:sy n="92" d="100"/>
        </p:scale>
        <p:origin x="-440" y="-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15146971702736"/>
          <c:y val="0.13971291866028709"/>
          <c:w val="0.84350146642579737"/>
          <c:h val="0.676922352409298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5">
                <a:lumMod val="20000"/>
                <a:lumOff val="80000"/>
              </a:schemeClr>
            </a:solidFill>
            <a:ln>
              <a:solidFill>
                <a:srgbClr val="002060"/>
              </a:solidFill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Y-arc experiment'!$M$72:$M$75</c:f>
              <c:strCache>
                <c:ptCount val="4"/>
                <c:pt idx="0">
                  <c:v>Restriction enzyme buffer overnight</c:v>
                </c:pt>
                <c:pt idx="1">
                  <c:v>TE buffer 37˚C few hours</c:v>
                </c:pt>
                <c:pt idx="2">
                  <c:v>TE buffer 37˚C overnight</c:v>
                </c:pt>
                <c:pt idx="3">
                  <c:v>TE buffer 45˚C few hours</c:v>
                </c:pt>
              </c:strCache>
            </c:strRef>
          </c:cat>
          <c:val>
            <c:numRef>
              <c:f>'Y-arc experiment'!$N$72:$N$75</c:f>
              <c:numCache>
                <c:formatCode>General</c:formatCode>
                <c:ptCount val="4"/>
                <c:pt idx="0">
                  <c:v>0.77438873212619697</c:v>
                </c:pt>
                <c:pt idx="1">
                  <c:v>0.69592895875342897</c:v>
                </c:pt>
                <c:pt idx="2">
                  <c:v>0.99773704274197705</c:v>
                </c:pt>
                <c:pt idx="3">
                  <c:v>0.668361003384002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AE-4BFF-8779-64153BB04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3251576"/>
        <c:axId val="383251904"/>
      </c:barChart>
      <c:catAx>
        <c:axId val="383251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83251904"/>
        <c:crosses val="autoZero"/>
        <c:auto val="1"/>
        <c:lblAlgn val="ctr"/>
        <c:lblOffset val="100"/>
        <c:noMultiLvlLbl val="0"/>
      </c:catAx>
      <c:valAx>
        <c:axId val="3832519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 b="0" i="0" u="none" strike="noStrike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 of Y-arc out of          6 kb fragments </a:t>
                </a:r>
                <a:endParaRPr lang="en-GB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83251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F47268-4878-42B1-B22A-2CB770BD67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036EC2-6EDD-4C86-973F-F07C2FCC97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D95A0D-473D-43AF-A012-310645909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3C723A-08C9-4B2D-B726-1794E73FE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B24CE8-D9C4-433E-B8BC-85CF9D5AA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6996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3041C2-4F9E-4F1D-9B14-A3D6F0CFEF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79CD6B-D4E7-4047-9809-D688CE3B9E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1950BE-B3F8-4267-99A7-8237F5DDE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57E938-D773-4A2D-8C3D-23221DE37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85992F-7BFA-46BF-BE58-A0CD729E6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4044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158D53C-E5E4-4F69-A977-C14B38177E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CD1B4E-BE03-42BF-89E2-C2FB8DF679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18034C-70C4-4758-8C3F-82AACB650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3CE47-4334-4896-A04B-98A8C4D01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FD7C36-7EFC-42F0-8585-4431062FD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317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4BB723-7C3E-46EB-B5D2-EECF2CD15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CEF71B-F031-418B-8422-DEC937C931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1E057C-B982-4F04-A392-6D7929110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1BCAE1-FC61-4692-BF4B-ABA2169DB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61E3FA-CBB7-4B6C-B547-E9AED289D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866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9D6C9-68A5-4AB3-9421-F270F494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D811CF-AEF5-4C0F-BADB-21DDC1FFAC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E04C15-9DE9-4221-BBA7-B925DEE22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8CE002-F3CD-4FCA-A66E-1A0C23708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B5C1CD-DE48-4024-B93D-73E468AEA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351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54BDD-9B22-4365-94B7-DE9BAC111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FCED4-3974-4F4B-887E-88A6CD892A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774D29-F46F-4D62-8426-4351EFE94D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1DF208-5FEA-49F8-B09F-EA500BBBE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53F4A0-08FB-42DC-B1AC-A9F72C836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F3C3D5-BBA2-47AE-B529-BC255871F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7058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4F195-E9E5-4BB1-8210-2F39E68D1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458857-2740-4FC1-B8AF-86A14D27F3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972312-9946-4C0E-BFBE-9C9F84C165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368811-7473-4936-9D49-DE52DD5B46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6FD1A9-3AB5-4A3F-B908-FD0F79EEB8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766287-A83D-4770-9F96-888E5FA11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81D823-2A5A-4396-A9DF-DA24D8EC0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C3D904-DD76-43AF-8FAF-A61B093F2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4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1335F3-A1EB-4BEC-BB0F-A03C7B98A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7E0ADD-9086-4493-A674-C469C13F4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740C32-E771-44DD-9CB8-D1BD88E5D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85C071-3A9A-4539-987A-33E2F9865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477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387AD5-0B67-4F49-9E4C-73A2E9F9E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84F783-BF83-4ED3-8BE7-F870D7798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B1162-CF7D-40BA-B9D1-DB1B3F547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9744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7FB35-1892-4E4D-826D-7D67940EF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2C02DB-1CB4-4FD7-A2A5-A136A4D837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E3876E-8650-4330-87BB-D667CC6D18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B944D7-7993-4A3F-8DC9-D4B6C7DD4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6DF7B0-A22F-4DF1-A3DE-7D58E2FDB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2D684A-DEF4-4C2A-9633-E85F1C2C8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322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0FA87-55A4-4C26-BF4D-0D43D8E96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321C76-E06C-4890-ABE4-EB5E3273A6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344257-6221-4C2D-ADFE-F1EA64579A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84A15A-E432-45AD-9628-B03F08ED7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6D3A36-5C41-400E-BF26-47D36CD6B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733246-4BD7-4380-9F42-55C2D204E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8244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3DF8C3-9339-489A-A564-6F80BEDD6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60AFB5-C968-4201-B121-0D648E3B18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DDDF9-15A1-4748-ACB4-320178F139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E908A-D05E-4B9D-B15F-D66A23997319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E4A3BA-7983-495C-BC68-1F648F6D6B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4EA3F8-FB40-4454-A648-49312453F5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80554-2B58-466F-8D74-E4E5BCDDE8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1942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6B772CC3-0B14-4970-A0F2-95B463F983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0872746"/>
              </p:ext>
            </p:extLst>
          </p:nvPr>
        </p:nvGraphicFramePr>
        <p:xfrm>
          <a:off x="3361460" y="2237197"/>
          <a:ext cx="5469080" cy="2654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61169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hirah Yasmin</dc:creator>
  <cp:lastModifiedBy>Tahirah Yasmin</cp:lastModifiedBy>
  <cp:revision>2</cp:revision>
  <dcterms:created xsi:type="dcterms:W3CDTF">2021-05-04T14:50:47Z</dcterms:created>
  <dcterms:modified xsi:type="dcterms:W3CDTF">2021-05-04T15:57:30Z</dcterms:modified>
</cp:coreProperties>
</file>